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1"/>
  </p:notesMasterIdLst>
  <p:sldIdLst>
    <p:sldId id="260" r:id="rId2"/>
    <p:sldId id="262" r:id="rId3"/>
    <p:sldId id="256" r:id="rId4"/>
    <p:sldId id="259" r:id="rId5"/>
    <p:sldId id="257" r:id="rId6"/>
    <p:sldId id="258" r:id="rId7"/>
    <p:sldId id="261" r:id="rId8"/>
    <p:sldId id="263" r:id="rId9"/>
    <p:sldId id="26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592"/>
    <p:restoredTop sz="89320"/>
  </p:normalViewPr>
  <p:slideViewPr>
    <p:cSldViewPr snapToGrid="0">
      <p:cViewPr varScale="1">
        <p:scale>
          <a:sx n="114" d="100"/>
          <a:sy n="114" d="100"/>
        </p:scale>
        <p:origin x="7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628044-114E-D64E-887F-8D5D9C95153B}" type="datetimeFigureOut">
              <a:rPr lang="en-US" smtClean="0"/>
              <a:t>9/1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379021-2C16-1444-BCB5-325D8CB94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2931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F379021-2C16-1444-BCB5-325D8CB9419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0092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379021-2C16-1444-BCB5-325D8CB9419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0421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379021-2C16-1444-BCB5-325D8CB9419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08703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379021-2C16-1444-BCB5-325D8CB9419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77185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379021-2C16-1444-BCB5-325D8CB9419B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64355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379021-2C16-1444-BCB5-325D8CB9419B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5870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6356F1-8DB9-7657-13E5-35372A5F13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CA99A6-0722-7095-53B3-DE2372520E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DA565B-83FB-6C6B-578D-B6DB00C87A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16E75-D42B-364D-8E41-962411359988}" type="datetimeFigureOut">
              <a:rPr lang="en-US" smtClean="0"/>
              <a:t>9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629D9E-E093-3E9C-6D46-11F207CFD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BE3038-6565-8BC8-F942-2FFF29A02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A3E8C-847A-5F49-9F43-E4403C64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950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25083-DFE5-A4C3-D78D-8B92B64627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350229-0985-9951-0524-8E89821704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9E4760-10EC-3CE9-BEFE-92F2E3D87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16E75-D42B-364D-8E41-962411359988}" type="datetimeFigureOut">
              <a:rPr lang="en-US" smtClean="0"/>
              <a:t>9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8E0282-D8D0-FE05-8C5A-06257854E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39A5A9-A022-0B66-9339-76B8FFA1F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A3E8C-847A-5F49-9F43-E4403C64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0601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ED32B9-331B-6D89-4D93-4AC37CE423B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32D858-BD3C-0233-2E09-F5EBAC2294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9F45FD-531B-5D22-8C08-F5C2C842A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16E75-D42B-364D-8E41-962411359988}" type="datetimeFigureOut">
              <a:rPr lang="en-US" smtClean="0"/>
              <a:t>9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B19AD9-B6FB-C973-561C-6559065F5C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D4707D-4493-E92D-FE17-AEF938BFA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A3E8C-847A-5F49-9F43-E4403C64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828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BD071B-9C85-2B74-C211-5F82F32F13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D28FB3-1A92-40D0-502A-CDB245571A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C07B0D-905C-D5B0-A642-E1CB2DD01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16E75-D42B-364D-8E41-962411359988}" type="datetimeFigureOut">
              <a:rPr lang="en-US" smtClean="0"/>
              <a:t>9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E01A00-0DCD-FF47-0A73-DCFBB4CD5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74A2F4-E83B-5CAB-1051-8444D2364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A3E8C-847A-5F49-9F43-E4403C64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404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D662E-BF33-481E-9EDD-48ADADF5A9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CC602F-00A3-ADF0-F280-0E5003D22F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B4DB61-746D-9117-B6E4-1001EAB34D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16E75-D42B-364D-8E41-962411359988}" type="datetimeFigureOut">
              <a:rPr lang="en-US" smtClean="0"/>
              <a:t>9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6C2259-66EF-0D65-EE43-86E707591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3DF72E-0BD4-EF00-CEC2-8242EFAE8A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A3E8C-847A-5F49-9F43-E4403C64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219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BCC4E0-A8B5-4436-0AD0-249A29458C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D40E1C-E449-A398-7E90-B8EF6E3882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74F027-32B6-5364-6630-DCE8A15CE5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2F1F07-63E1-9BFC-1A49-7A0455D47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16E75-D42B-364D-8E41-962411359988}" type="datetimeFigureOut">
              <a:rPr lang="en-US" smtClean="0"/>
              <a:t>9/1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106A1A-26C6-93BC-6EB9-4B81EFBFB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620BDD-6A7C-18D1-8647-BD5760D23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A3E8C-847A-5F49-9F43-E4403C64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705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AEC14F-73EC-19DE-0130-54BE16E2B0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5A7834-E92D-EA04-6BDF-AB46E7DD6B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03C3F7-5DB4-50C7-2379-0C98170AF7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057B598-0C81-ADFB-9010-758D9AE626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6C8B8A-6B06-5FCE-3F88-1F91AABB2B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E982BFD-425B-B139-4BE1-9ECF251E8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16E75-D42B-364D-8E41-962411359988}" type="datetimeFigureOut">
              <a:rPr lang="en-US" smtClean="0"/>
              <a:t>9/18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7566A11-DA9A-9A5D-68C5-EEC5209D03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802C15-8BA9-6A0C-827B-5CD2A4B260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A3E8C-847A-5F49-9F43-E4403C64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719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E4328-CC48-166F-E3D1-5FD3583FFD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3B2FC64-8649-556A-8339-FD5237FBC2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16E75-D42B-364D-8E41-962411359988}" type="datetimeFigureOut">
              <a:rPr lang="en-US" smtClean="0"/>
              <a:t>9/18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2365AE6-2D20-A232-2E07-39661E393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9C96A75-C026-E685-98AA-AB44CBCA8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A3E8C-847A-5F49-9F43-E4403C64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271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365DE89-F7B9-14EA-35D3-86292CF13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16E75-D42B-364D-8E41-962411359988}" type="datetimeFigureOut">
              <a:rPr lang="en-US" smtClean="0"/>
              <a:t>9/18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296EC6-0952-73A5-3DFE-4709F5A89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BDB6F7-093B-01CC-FB5D-FBB858F01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A3E8C-847A-5F49-9F43-E4403C64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090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51D859-14B0-A8A8-A93A-B14F9B2191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6118FC-8C48-5DF5-4DF9-4958AD6E5E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F73F12-6412-847B-1F07-4274281EE3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DEFD49-8BE7-8F23-F734-46332AB8A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16E75-D42B-364D-8E41-962411359988}" type="datetimeFigureOut">
              <a:rPr lang="en-US" smtClean="0"/>
              <a:t>9/1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C756C5-401A-4023-42AF-C86EDD4EA7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91EF50-050C-7DC8-DB8F-B9415F7CE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A3E8C-847A-5F49-9F43-E4403C64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581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A34311-64F3-CF6D-CC57-CF86FFED71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F58B69D-CB25-6ED1-0CA0-B9D4058DF7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668D15-375A-8CAF-4F63-A848D795E8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09EB15-B7FC-3CD8-381E-11E4DBDF20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16E75-D42B-364D-8E41-962411359988}" type="datetimeFigureOut">
              <a:rPr lang="en-US" smtClean="0"/>
              <a:t>9/1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CA9C2E-4C48-3286-219B-15D3856256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6D351F-44C2-BB94-25F9-B64989C259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A3E8C-847A-5F49-9F43-E4403C64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5638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F9CEE2A-7AB5-D7E7-AF1F-4488B4B45B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920B57-C1F5-02DE-A1F5-542585FE28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06EDDA-F378-4F38-7022-8184C863DB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B16E75-D42B-364D-8E41-962411359988}" type="datetimeFigureOut">
              <a:rPr lang="en-US" smtClean="0"/>
              <a:t>9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B1BA32-F5FA-1573-FA2C-DF054B62EB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4BA172-6FEB-7142-8699-437A64F80A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3A3E8C-847A-5F49-9F43-E4403C644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854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F542B08D-C31D-51E5-B943-79D46E244510}"/>
              </a:ext>
            </a:extLst>
          </p:cNvPr>
          <p:cNvSpPr txBox="1"/>
          <p:nvPr/>
        </p:nvSpPr>
        <p:spPr>
          <a:xfrm>
            <a:off x="169826" y="5515154"/>
            <a:ext cx="1185234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Body weight and food intake were moderately impacted by stress and exercise.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The mean change in body weight between day 1 and day 41 of the experiment is shown with standard error bars. (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Rats in the non-stress runner group ate the most , no differences were detected among the other groups. The mean amount of food consumed on select days throughout the experiment is shown with standard error bars. *** indicates p&lt;0.01.</a:t>
            </a:r>
            <a:r>
              <a:rPr lang="en-US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419" y="739720"/>
            <a:ext cx="11668755" cy="45419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49333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542B08D-C31D-51E5-B943-79D46E244510}"/>
              </a:ext>
            </a:extLst>
          </p:cNvPr>
          <p:cNvSpPr txBox="1"/>
          <p:nvPr/>
        </p:nvSpPr>
        <p:spPr>
          <a:xfrm>
            <a:off x="183829" y="5981684"/>
            <a:ext cx="1185234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Microglia Identification.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 score was generated using a curated list of microglia marker genes and each nucleus in the data set was given a score with the UMAP plot showing expression of the score and the violin plot showing how the score differed across clusters.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Similarly, a score was generated using a curated list of macrophage marker genes.  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5895" y="98534"/>
            <a:ext cx="8193734" cy="5883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02517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B952AA9-4947-BFA5-29EB-63E272D4A3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826" y="119270"/>
            <a:ext cx="11852348" cy="537924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108F7D3-75E8-3F40-70BA-FB429E5B0B50}"/>
              </a:ext>
            </a:extLst>
          </p:cNvPr>
          <p:cNvSpPr txBox="1"/>
          <p:nvPr/>
        </p:nvSpPr>
        <p:spPr>
          <a:xfrm>
            <a:off x="169827" y="5498510"/>
            <a:ext cx="1185234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Pairwise comparisons of microglial metabolism and inflammatory change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the metabolism, M1 (pro-inflammatory), and M2 (anti-inflammatory) activation states of microglia did not show subcluster or treatment group differences between the no stress (NS_Sed) and stress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_Sed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groups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the sedentary (NS_Sed) and exercise (or exercise enrichment) (NS_Run) groups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18197766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E9ADD2DB-4128-F9AE-81CD-6A586771DB79}"/>
              </a:ext>
            </a:extLst>
          </p:cNvPr>
          <p:cNvSpPr txBox="1"/>
          <p:nvPr/>
        </p:nvSpPr>
        <p:spPr>
          <a:xfrm>
            <a:off x="169826" y="5788442"/>
            <a:ext cx="1185234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. Exercise-enrichment cluster is consistent across individuals and groups. (A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et and re-clustering of microglia between no stress runners (NS_Run) and no stress sedentary (NS_Sed) across individuals shows the consistent presence of a cluster specific to exercise (subcluster 3)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esence of a subcluster associated with exercise is even present across all four groups with the no stress runners and stress runners (S_Run) showing the presence of a subcluster that is not present in either of the sedentary groups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5552CF6-A00F-37DB-5B9C-90099F4892A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9000"/>
          <a:stretch/>
        </p:blipFill>
        <p:spPr>
          <a:xfrm>
            <a:off x="403218" y="0"/>
            <a:ext cx="11385564" cy="57884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38601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4223BF4-5FE3-9FA5-31FC-039E1E239B57}"/>
              </a:ext>
            </a:extLst>
          </p:cNvPr>
          <p:cNvSpPr txBox="1"/>
          <p:nvPr/>
        </p:nvSpPr>
        <p:spPr>
          <a:xfrm>
            <a:off x="169826" y="4055372"/>
            <a:ext cx="1185234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. Individual running distance impacts gene expression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the difference in significant numbers of DEGs in the NS_Run/NS_Sed analysis and the individual total running distance analysis shows a very low amount of overlap that was no statistically significant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ith examples of genes that were highly correlated with running distance plotted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97C9F89E-13A5-A866-1EA9-2F5BF33A06A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49735"/>
          <a:stretch/>
        </p:blipFill>
        <p:spPr>
          <a:xfrm>
            <a:off x="0" y="1535941"/>
            <a:ext cx="12337031" cy="21593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96256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041DDAB-BCD4-FD6C-2BA7-DC7969548EE8}"/>
              </a:ext>
            </a:extLst>
          </p:cNvPr>
          <p:cNvSpPr txBox="1"/>
          <p:nvPr/>
        </p:nvSpPr>
        <p:spPr>
          <a:xfrm>
            <a:off x="169826" y="5707303"/>
            <a:ext cx="1185234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6. Comparison of ANCOVA, 2x2, total running, and no stress versus stress analyse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o stress versus stress analysis shared 19 significant genes with the main effect of stress in the 2x2 analysis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sedentary versus runner and main effect of exercise in the 2x2 analysis shared 185 significant genes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main effect of stress in the ANCOVA and the no stress versus stress analysis shared 1 significant gene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ANCOVA for individual total running levels shared 303 significant genes with the total running analysis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Examples of genes ANCOVA genes that were significant for the main effect of total individual running level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stress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the interaction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re shown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CB5EE1C-348E-7447-9237-2E16CF9C41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2162" y="0"/>
            <a:ext cx="7507676" cy="57073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5100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46DB29E-6112-BCB0-F6CE-AA21A1662155}"/>
              </a:ext>
            </a:extLst>
          </p:cNvPr>
          <p:cNvSpPr txBox="1"/>
          <p:nvPr/>
        </p:nvSpPr>
        <p:spPr>
          <a:xfrm>
            <a:off x="169825" y="5837932"/>
            <a:ext cx="1185234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7. Overlapping DEGs between stress and exercise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Eight genes were identified as overlapping between the analyses measuring the effects of stress and exercise on gene expression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C865762-2F88-073F-41F3-6D16598A13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6042" y="84112"/>
            <a:ext cx="10199915" cy="56231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8860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A18DDE4C-9EA7-B3EA-8808-6D4C9261374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3032" y="401444"/>
            <a:ext cx="11965936" cy="440218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B24624F-C1FE-883C-1F62-6D8102C4DD06}"/>
              </a:ext>
            </a:extLst>
          </p:cNvPr>
          <p:cNvSpPr txBox="1"/>
          <p:nvPr/>
        </p:nvSpPr>
        <p:spPr>
          <a:xfrm>
            <a:off x="169826" y="5079649"/>
            <a:ext cx="1185234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8. Differences between mature and immature subcluster in stress versus no stress analysi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&amp; 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 comparison of gene expression between the relatively immature and mature subclusters identified 4,404 DEGs, the vast majority of which were upregulated in the immature subcluster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ot plot highlighting GO terms that were significantly enriched among maturity-DEGs. </a:t>
            </a:r>
          </a:p>
        </p:txBody>
      </p:sp>
    </p:spTree>
    <p:extLst>
      <p:ext uri="{BB962C8B-B14F-4D97-AF65-F5344CB8AC3E}">
        <p14:creationId xmlns:p14="http://schemas.microsoft.com/office/powerpoint/2010/main" val="411767638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4DDB0AB-5BA1-E51F-98B8-FE1151D17834}"/>
              </a:ext>
            </a:extLst>
          </p:cNvPr>
          <p:cNvSpPr txBox="1"/>
          <p:nvPr/>
        </p:nvSpPr>
        <p:spPr>
          <a:xfrm>
            <a:off x="167267" y="6105561"/>
            <a:ext cx="1185234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9. Mediation analysis reveals genes with effects of stress on running and of stress on gene expression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Examples of genes that were significant mediators of the stress-induced reduction in wheel running.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Examples of genes in which stress affects gene expression via running. 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2A24661D-E139-C3F9-F0C5-4ACA965352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26012" y="229219"/>
            <a:ext cx="8539976" cy="55540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9491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3</TotalTime>
  <Words>710</Words>
  <Application>Microsoft Macintosh PowerPoint</Application>
  <PresentationFormat>Widescreen</PresentationFormat>
  <Paragraphs>15</Paragraphs>
  <Slides>9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olly, Meghan Grace</dc:creator>
  <cp:lastModifiedBy>Connolly, Meghan Grace</cp:lastModifiedBy>
  <cp:revision>32</cp:revision>
  <dcterms:created xsi:type="dcterms:W3CDTF">2023-12-16T20:31:18Z</dcterms:created>
  <dcterms:modified xsi:type="dcterms:W3CDTF">2024-09-18T16:39:28Z</dcterms:modified>
</cp:coreProperties>
</file>